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Средний стиль 2 — акцент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30305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48233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84867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93700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00656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36164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59014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59412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86180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9336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01479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0078C1-1EEA-4F0D-ABCB-5CF55768C7E0}" type="datetimeFigureOut">
              <a:rPr lang="ru-RU" smtClean="0"/>
              <a:t>25.01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B9E2C-5904-46F2-8161-06316FEF6EC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92888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Рисунок 4" descr="Изображение выглядит как текст, накладные волосы&#10;&#10;Автоматически созданное описание">
            <a:extLst>
              <a:ext uri="{FF2B5EF4-FFF2-40B4-BE49-F238E27FC236}">
                <a16:creationId xmlns:a16="http://schemas.microsoft.com/office/drawing/2014/main" id="{9A57FC19-91F6-4CFE-B912-AEC1B1139E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2302" y="1194674"/>
            <a:ext cx="6121400" cy="29083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141DF6F-F507-48BA-89BB-6D78B5CE9777}"/>
              </a:ext>
            </a:extLst>
          </p:cNvPr>
          <p:cNvSpPr txBox="1"/>
          <p:nvPr/>
        </p:nvSpPr>
        <p:spPr>
          <a:xfrm>
            <a:off x="2684477" y="4328719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PSPDPS8</a:t>
            </a:r>
            <a:endParaRPr lang="ru-RU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9CD4980-8177-4074-9ABB-C018F3B2935A}"/>
              </a:ext>
            </a:extLst>
          </p:cNvPr>
          <p:cNvSpPr txBox="1"/>
          <p:nvPr/>
        </p:nvSpPr>
        <p:spPr>
          <a:xfrm>
            <a:off x="5605244" y="4328719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PSPDPS2d</a:t>
            </a:r>
            <a:endParaRPr lang="ru-RU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015D8F7-8D7D-4D97-8A83-92CC71009167}"/>
              </a:ext>
            </a:extLst>
          </p:cNvPr>
          <p:cNvSpPr txBox="1"/>
          <p:nvPr/>
        </p:nvSpPr>
        <p:spPr>
          <a:xfrm>
            <a:off x="486561" y="5469622"/>
            <a:ext cx="8324153" cy="11560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Fig. S1. The IPSPDPS8 (PARK2-PD2) and IPSPDPS2d (PARK2-PD3) cell line staining with antibodies against the markers of pluripotency: Oct4 (red), SSEA-4 (green) and DAPI (blue). Х100.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20388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Рисунок 2">
            <a:extLst>
              <a:ext uri="{FF2B5EF4-FFF2-40B4-BE49-F238E27FC236}">
                <a16:creationId xmlns:a16="http://schemas.microsoft.com/office/drawing/2014/main" id="{9C695F4E-CB00-4E51-840A-03350B0476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5420" y="117277"/>
            <a:ext cx="6233160" cy="46268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CB20AE0-6B7D-40A0-ABF8-2358AE3CBF3B}"/>
              </a:ext>
            </a:extLst>
          </p:cNvPr>
          <p:cNvSpPr txBox="1"/>
          <p:nvPr/>
        </p:nvSpPr>
        <p:spPr>
          <a:xfrm>
            <a:off x="2650921" y="498306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PSPDPS8</a:t>
            </a:r>
            <a:endParaRPr lang="ru-RU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9A4DE0C-20DF-44CA-8088-FD1A918AD43D}"/>
              </a:ext>
            </a:extLst>
          </p:cNvPr>
          <p:cNvSpPr txBox="1"/>
          <p:nvPr/>
        </p:nvSpPr>
        <p:spPr>
          <a:xfrm>
            <a:off x="5571688" y="498306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PSPDPS2d</a:t>
            </a:r>
            <a:endParaRPr lang="ru-RU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4FF4056-F72E-43B0-B1B1-D91A2E94549E}"/>
              </a:ext>
            </a:extLst>
          </p:cNvPr>
          <p:cNvSpPr txBox="1"/>
          <p:nvPr/>
        </p:nvSpPr>
        <p:spPr>
          <a:xfrm>
            <a:off x="213920" y="5515209"/>
            <a:ext cx="8716160" cy="11560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Fig. S2. Immunocytochemical analysis of differentiated iPSCs derivatives for the ability to form cell derivatives of the threegerm layers. A: shown are markers of mesoderm - Desmin (green), entoderm- </a:t>
            </a:r>
            <a:r>
              <a:rPr lang="el-GR" sz="160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fetoprotein (red) and DAPI (blue).  B: ectoderm-tubbIII (green) and DAPI (blue). X100.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CAC2579-D66C-499D-A444-A82CA8F74EBB}"/>
              </a:ext>
            </a:extLst>
          </p:cNvPr>
          <p:cNvSpPr txBox="1"/>
          <p:nvPr/>
        </p:nvSpPr>
        <p:spPr>
          <a:xfrm>
            <a:off x="687897" y="11325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ru-RU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98C03A-266F-46FC-B7C5-7B6CC4C74694}"/>
              </a:ext>
            </a:extLst>
          </p:cNvPr>
          <p:cNvSpPr txBox="1"/>
          <p:nvPr/>
        </p:nvSpPr>
        <p:spPr>
          <a:xfrm>
            <a:off x="687897" y="3429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ru-RU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40684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Рисунок 2" descr="Изображение выглядит как текст, дерево, красный, сочный&#10;&#10;Автоматически созданное описание">
            <a:extLst>
              <a:ext uri="{FF2B5EF4-FFF2-40B4-BE49-F238E27FC236}">
                <a16:creationId xmlns:a16="http://schemas.microsoft.com/office/drawing/2014/main" id="{DC1CED4D-9FDC-46C3-BFBA-CD72CBE04F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7941" y="436227"/>
            <a:ext cx="6788118" cy="418610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4BEBA23-4DD5-43B9-9A58-02D077616919}"/>
              </a:ext>
            </a:extLst>
          </p:cNvPr>
          <p:cNvSpPr txBox="1"/>
          <p:nvPr/>
        </p:nvSpPr>
        <p:spPr>
          <a:xfrm>
            <a:off x="213920" y="5576248"/>
            <a:ext cx="8716160" cy="7867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Fig. S3. Immunocytochemical analysis of NPs. Staining with antibodies against the NP marker Sox1. </a:t>
            </a:r>
          </a:p>
          <a:p>
            <a:pPr>
              <a:lnSpc>
                <a:spcPct val="150000"/>
              </a:lnSpc>
            </a:pP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1, 2, 3- healthy donors, 4, 5, 6- patients with PD. X100.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73237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Рисунок 2" descr="Изображение выглядит как текст, дерево, другой, цветной&#10;&#10;Автоматически созданное описание">
            <a:extLst>
              <a:ext uri="{FF2B5EF4-FFF2-40B4-BE49-F238E27FC236}">
                <a16:creationId xmlns:a16="http://schemas.microsoft.com/office/drawing/2014/main" id="{2C6F9127-696E-4B0F-AD00-A01C2D643C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3" y="1541024"/>
            <a:ext cx="8964094" cy="21720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97E608B-5EB6-4322-94BD-79CCF0E1CA2E}"/>
              </a:ext>
            </a:extLst>
          </p:cNvPr>
          <p:cNvSpPr txBox="1"/>
          <p:nvPr/>
        </p:nvSpPr>
        <p:spPr>
          <a:xfrm>
            <a:off x="203600" y="3818171"/>
            <a:ext cx="128028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N HD1.1S</a:t>
            </a:r>
          </a:p>
          <a:p>
            <a:endParaRPr lang="en-US" sz="160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norma2dn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FDB25A3-BB01-4F76-A239-4FF5975E92D1}"/>
              </a:ext>
            </a:extLst>
          </p:cNvPr>
          <p:cNvSpPr txBox="1"/>
          <p:nvPr/>
        </p:nvSpPr>
        <p:spPr>
          <a:xfrm>
            <a:off x="1748977" y="3818171"/>
            <a:ext cx="124264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N FD3.9L</a:t>
            </a:r>
          </a:p>
          <a:p>
            <a:endParaRPr lang="en-US" sz="1600">
              <a:latin typeface="Times New Roman" panose="02020603050405020304" pitchFamily="18" charset="0"/>
            </a:endParaRPr>
          </a:p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norma3dn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062FAEF-C5ED-4DE1-A935-A9AC6C446BED}"/>
              </a:ext>
            </a:extLst>
          </p:cNvPr>
          <p:cNvSpPr txBox="1"/>
          <p:nvPr/>
        </p:nvSpPr>
        <p:spPr>
          <a:xfrm>
            <a:off x="3327631" y="3818171"/>
            <a:ext cx="104227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N RG2L</a:t>
            </a:r>
          </a:p>
          <a:p>
            <a:pPr algn="ctr"/>
            <a:endParaRPr lang="en-US" sz="1600">
              <a:latin typeface="Times New Roman" panose="02020603050405020304" pitchFamily="18" charset="0"/>
            </a:endParaRPr>
          </a:p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norma1dn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1BAAB7-63E1-4E9F-B07F-6580750B3B68}"/>
              </a:ext>
            </a:extLst>
          </p:cNvPr>
          <p:cNvSpPr txBox="1"/>
          <p:nvPr/>
        </p:nvSpPr>
        <p:spPr>
          <a:xfrm>
            <a:off x="4605771" y="3818171"/>
            <a:ext cx="145142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N PDS14</a:t>
            </a:r>
          </a:p>
          <a:p>
            <a:pPr algn="ctr"/>
            <a:endParaRPr lang="en-US" sz="1600">
              <a:latin typeface="Times New Roman" panose="02020603050405020304" pitchFamily="18" charset="0"/>
            </a:endParaRPr>
          </a:p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PARK2-PD3dn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2BBDE1A-BC65-4A12-89A6-7BEE289E7D0A}"/>
              </a:ext>
            </a:extLst>
          </p:cNvPr>
          <p:cNvSpPr txBox="1"/>
          <p:nvPr/>
        </p:nvSpPr>
        <p:spPr>
          <a:xfrm>
            <a:off x="6069844" y="3818171"/>
            <a:ext cx="153939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N PDS13</a:t>
            </a:r>
          </a:p>
          <a:p>
            <a:endParaRPr lang="en-US" sz="1600">
              <a:latin typeface="Times New Roman" panose="02020603050405020304" pitchFamily="18" charset="0"/>
            </a:endParaRPr>
          </a:p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PARK2-PD2dn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847EE00-30AB-4B12-992E-10DF8A9FF417}"/>
              </a:ext>
            </a:extLst>
          </p:cNvPr>
          <p:cNvSpPr txBox="1"/>
          <p:nvPr/>
        </p:nvSpPr>
        <p:spPr>
          <a:xfrm>
            <a:off x="7598975" y="3818171"/>
            <a:ext cx="153939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N PDL1.5L</a:t>
            </a:r>
          </a:p>
          <a:p>
            <a:endParaRPr lang="en-US" sz="1600">
              <a:latin typeface="Times New Roman" panose="02020603050405020304" pitchFamily="18" charset="0"/>
            </a:endParaRPr>
          </a:p>
          <a:p>
            <a:pPr algn="ctr"/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PARK2-PD1dn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3440DAE-DCD5-47C9-8424-AF050161C6F0}"/>
              </a:ext>
            </a:extLst>
          </p:cNvPr>
          <p:cNvSpPr txBox="1"/>
          <p:nvPr/>
        </p:nvSpPr>
        <p:spPr>
          <a:xfrm>
            <a:off x="213920" y="5576248"/>
            <a:ext cx="8716160" cy="7867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Fig. S4. Immunofluorescence staining of neuronal cell cultures with TUBB3 (green - total neuronal population), tyrosine hydroxylase (red - dopaminergic neurons). X100.</a:t>
            </a:r>
            <a:endParaRPr lang="ru-RU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36422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Таблица 3">
            <a:extLst>
              <a:ext uri="{FF2B5EF4-FFF2-40B4-BE49-F238E27FC236}">
                <a16:creationId xmlns:a16="http://schemas.microsoft.com/office/drawing/2014/main" id="{3A1CF63E-2523-4EC2-8DF8-7490730907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473845"/>
              </p:ext>
            </p:extLst>
          </p:nvPr>
        </p:nvGraphicFramePr>
        <p:xfrm>
          <a:off x="1723938" y="1212763"/>
          <a:ext cx="5696124" cy="4432474"/>
        </p:xfrm>
        <a:graphic>
          <a:graphicData uri="http://schemas.openxmlformats.org/drawingml/2006/table">
            <a:tbl>
              <a:tblPr firstRow="1" firstCol="1" bandRow="1"/>
              <a:tblGrid>
                <a:gridCol w="1304060">
                  <a:extLst>
                    <a:ext uri="{9D8B030D-6E8A-4147-A177-3AD203B41FA5}">
                      <a16:colId xmlns:a16="http://schemas.microsoft.com/office/drawing/2014/main" val="3244791112"/>
                    </a:ext>
                  </a:extLst>
                </a:gridCol>
                <a:gridCol w="842602">
                  <a:extLst>
                    <a:ext uri="{9D8B030D-6E8A-4147-A177-3AD203B41FA5}">
                      <a16:colId xmlns:a16="http://schemas.microsoft.com/office/drawing/2014/main" val="4230023541"/>
                    </a:ext>
                  </a:extLst>
                </a:gridCol>
                <a:gridCol w="653017">
                  <a:extLst>
                    <a:ext uri="{9D8B030D-6E8A-4147-A177-3AD203B41FA5}">
                      <a16:colId xmlns:a16="http://schemas.microsoft.com/office/drawing/2014/main" val="34256102"/>
                    </a:ext>
                  </a:extLst>
                </a:gridCol>
                <a:gridCol w="1306033">
                  <a:extLst>
                    <a:ext uri="{9D8B030D-6E8A-4147-A177-3AD203B41FA5}">
                      <a16:colId xmlns:a16="http://schemas.microsoft.com/office/drawing/2014/main" val="3946646662"/>
                    </a:ext>
                  </a:extLst>
                </a:gridCol>
                <a:gridCol w="839969">
                  <a:extLst>
                    <a:ext uri="{9D8B030D-6E8A-4147-A177-3AD203B41FA5}">
                      <a16:colId xmlns:a16="http://schemas.microsoft.com/office/drawing/2014/main" val="3772635469"/>
                    </a:ext>
                  </a:extLst>
                </a:gridCol>
                <a:gridCol w="750443">
                  <a:extLst>
                    <a:ext uri="{9D8B030D-6E8A-4147-A177-3AD203B41FA5}">
                      <a16:colId xmlns:a16="http://schemas.microsoft.com/office/drawing/2014/main" val="2414739656"/>
                    </a:ext>
                  </a:extLst>
                </a:gridCol>
              </a:tblGrid>
              <a:tr h="30069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mple Name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al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eqs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lions)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 GC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mple Name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al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eqs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lions)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 GC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2849903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1np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1dn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6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6541136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1np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.6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1dn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8978293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1np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.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1dn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4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4709268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p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0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2dn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7938041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p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.5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2dn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.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6735240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p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2dn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2750817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p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3dn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.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1344882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p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7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3dn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0902046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</a:t>
                      </a: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p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.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3dn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6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7532571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1np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3.0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1dn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7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3382224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1np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.4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1dn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8284555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1np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.5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1dn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9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4620117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2np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.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2dn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.6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8951712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2np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8.6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2dn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.5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865653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2np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.7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2dn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2620864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3np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.7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3dn_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4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2020734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3np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.7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3dn_2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.7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4726088"/>
                  </a:ext>
                </a:extLst>
              </a:tr>
              <a:tr h="2250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3np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.5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K2-PD3dn_3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1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ru-RU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%</a:t>
                      </a:r>
                      <a:endParaRPr lang="ru-RU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009" marR="54009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2553706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AB47A856-60C0-45A3-AF4A-3A6E08CC83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280" y="410357"/>
            <a:ext cx="782543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ru-RU" sz="1400" b="0" i="0" u="none" strike="noStrike" cap="none" normalizeH="0" baseline="0">
                <a:ln>
                  <a:noFill/>
                </a:ln>
                <a:solidFill>
                  <a:srgbClr val="FFFFFF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ru-RU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S1. General Statistics of bioinformatics analyses.</a:t>
            </a:r>
            <a:endParaRPr kumimoji="0" lang="en-US" altLang="ru-RU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095423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430</Words>
  <Application>Microsoft Office PowerPoint</Application>
  <PresentationFormat>Экран (4:3)</PresentationFormat>
  <Paragraphs>144</Paragraphs>
  <Slides>5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Valentina Nenasheva</dc:creator>
  <cp:lastModifiedBy>Valentina Nenasheva</cp:lastModifiedBy>
  <cp:revision>5</cp:revision>
  <dcterms:created xsi:type="dcterms:W3CDTF">2022-01-21T07:52:05Z</dcterms:created>
  <dcterms:modified xsi:type="dcterms:W3CDTF">2022-01-25T08:48:27Z</dcterms:modified>
</cp:coreProperties>
</file>